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96BC75A-2C92-4255-8B00-A869194B2788}" v="3" dt="2026-01-23T09:00:28.62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96" d="100"/>
          <a:sy n="96" d="100"/>
        </p:scale>
        <p:origin x="20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e VERT" userId="4bc5254d-c1cf-4fbd-b0b2-f5c9e026c750" providerId="ADAL" clId="{596BC75A-2C92-4255-8B00-A869194B2788}"/>
    <pc:docChg chg="addSld delSld modSld">
      <pc:chgData name="Laure VERT" userId="4bc5254d-c1cf-4fbd-b0b2-f5c9e026c750" providerId="ADAL" clId="{596BC75A-2C92-4255-8B00-A869194B2788}" dt="2026-01-23T09:00:31.380" v="5" actId="1076"/>
      <pc:docMkLst>
        <pc:docMk/>
      </pc:docMkLst>
      <pc:sldChg chg="del">
        <pc:chgData name="Laure VERT" userId="4bc5254d-c1cf-4fbd-b0b2-f5c9e026c750" providerId="ADAL" clId="{596BC75A-2C92-4255-8B00-A869194B2788}" dt="2026-01-23T08:59:21.030" v="0" actId="47"/>
        <pc:sldMkLst>
          <pc:docMk/>
          <pc:sldMk cId="1888939319" sldId="256"/>
        </pc:sldMkLst>
      </pc:sldChg>
      <pc:sldChg chg="del">
        <pc:chgData name="Laure VERT" userId="4bc5254d-c1cf-4fbd-b0b2-f5c9e026c750" providerId="ADAL" clId="{596BC75A-2C92-4255-8B00-A869194B2788}" dt="2026-01-23T08:59:21.030" v="0" actId="47"/>
        <pc:sldMkLst>
          <pc:docMk/>
          <pc:sldMk cId="2049254573" sldId="260"/>
        </pc:sldMkLst>
      </pc:sldChg>
      <pc:sldChg chg="addSp modSp new mod">
        <pc:chgData name="Laure VERT" userId="4bc5254d-c1cf-4fbd-b0b2-f5c9e026c750" providerId="ADAL" clId="{596BC75A-2C92-4255-8B00-A869194B2788}" dt="2026-01-23T09:00:31.380" v="5" actId="1076"/>
        <pc:sldMkLst>
          <pc:docMk/>
          <pc:sldMk cId="2290430716" sldId="262"/>
        </pc:sldMkLst>
        <pc:spChg chg="add mod">
          <ac:chgData name="Laure VERT" userId="4bc5254d-c1cf-4fbd-b0b2-f5c9e026c750" providerId="ADAL" clId="{596BC75A-2C92-4255-8B00-A869194B2788}" dt="2026-01-23T09:00:14.288" v="3"/>
          <ac:spMkLst>
            <pc:docMk/>
            <pc:sldMk cId="2290430716" sldId="262"/>
            <ac:spMk id="3" creationId="{21084975-4B95-A6F1-61D7-B549A700AE3D}"/>
          </ac:spMkLst>
        </pc:spChg>
        <pc:graphicFrameChg chg="add mod">
          <ac:chgData name="Laure VERT" userId="4bc5254d-c1cf-4fbd-b0b2-f5c9e026c750" providerId="ADAL" clId="{596BC75A-2C92-4255-8B00-A869194B2788}" dt="2026-01-23T09:00:12.039" v="2"/>
          <ac:graphicFrameMkLst>
            <pc:docMk/>
            <pc:sldMk cId="2290430716" sldId="262"/>
            <ac:graphicFrameMk id="2" creationId="{427EC9AB-9B7A-8536-F5AA-A033441EB804}"/>
          </ac:graphicFrameMkLst>
        </pc:graphicFrameChg>
        <pc:picChg chg="add mod">
          <ac:chgData name="Laure VERT" userId="4bc5254d-c1cf-4fbd-b0b2-f5c9e026c750" providerId="ADAL" clId="{596BC75A-2C92-4255-8B00-A869194B2788}" dt="2026-01-23T09:00:31.380" v="5" actId="1076"/>
          <ac:picMkLst>
            <pc:docMk/>
            <pc:sldMk cId="2290430716" sldId="262"/>
            <ac:picMk id="4" creationId="{F47C48CF-877F-F172-1BFF-69D2FD67BAD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9567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4597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0795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9481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6506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8253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8580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1024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2415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438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9841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8CDDD3-97DF-415F-805F-F92A58289823}" type="datetimeFigureOut">
              <a:rPr lang="fr-FR" smtClean="0"/>
              <a:t>23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B9DCC2E-4FEF-47AF-832E-745A8E53784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680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7A9F4AC-239E-854E-7ADB-F68893A3CE7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AF057FB-5DCC-F8F4-B213-554EC98E9E5E}"/>
              </a:ext>
            </a:extLst>
          </p:cNvPr>
          <p:cNvSpPr/>
          <p:nvPr/>
        </p:nvSpPr>
        <p:spPr>
          <a:xfrm>
            <a:off x="133054" y="48922"/>
            <a:ext cx="65918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>
                <a:latin typeface="Helvetica"/>
                <a:cs typeface="Helvetica"/>
              </a:rPr>
              <a:t>SUP FIGURE S1: Enriched pathways of aged-related DEGs in skin cells 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352E34B-EF14-4566-1BDB-80EB3496EAC1}"/>
              </a:ext>
            </a:extLst>
          </p:cNvPr>
          <p:cNvSpPr/>
          <p:nvPr/>
        </p:nvSpPr>
        <p:spPr>
          <a:xfrm>
            <a:off x="169499" y="423128"/>
            <a:ext cx="30441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4E8D2A88-F001-D11E-066A-9236E9D802F0}"/>
              </a:ext>
            </a:extLst>
          </p:cNvPr>
          <p:cNvSpPr txBox="1"/>
          <p:nvPr/>
        </p:nvSpPr>
        <p:spPr>
          <a:xfrm>
            <a:off x="521977" y="3333584"/>
            <a:ext cx="60106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A- Venn view of DEGs from FB (blue), </a:t>
            </a:r>
            <a:r>
              <a:rPr lang="en-US" sz="800" dirty="0" err="1"/>
              <a:t>KTd</a:t>
            </a:r>
            <a:r>
              <a:rPr lang="en-US" sz="800" dirty="0"/>
              <a:t> (yellow) and </a:t>
            </a:r>
            <a:r>
              <a:rPr lang="en-US" sz="800" dirty="0" err="1"/>
              <a:t>Ktu</a:t>
            </a:r>
            <a:r>
              <a:rPr lang="en-US" sz="800" dirty="0"/>
              <a:t> (purple).</a:t>
            </a:r>
          </a:p>
          <a:p>
            <a:r>
              <a:rPr lang="en-US" sz="800" dirty="0"/>
              <a:t>B- Enriched </a:t>
            </a:r>
            <a:r>
              <a:rPr lang="en-US" sz="800" dirty="0" err="1"/>
              <a:t>Wikipathways</a:t>
            </a:r>
            <a:r>
              <a:rPr lang="en-US" sz="800" dirty="0"/>
              <a:t> in FB (HNF) and KT (HNK). “Count” indicate gene number modulated in each pathways.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8A4E4A0-2DCC-234B-D0B7-B87F6B846732}"/>
              </a:ext>
            </a:extLst>
          </p:cNvPr>
          <p:cNvSpPr/>
          <p:nvPr/>
        </p:nvSpPr>
        <p:spPr>
          <a:xfrm>
            <a:off x="2526628" y="383907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>
                <a:latin typeface="Helvetica"/>
                <a:cs typeface="Helvetica"/>
              </a:rPr>
              <a:t>B</a:t>
            </a:r>
          </a:p>
        </p:txBody>
      </p: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42280ADF-2EC5-2C15-ABD7-7639247E4673}"/>
              </a:ext>
            </a:extLst>
          </p:cNvPr>
          <p:cNvGrpSpPr/>
          <p:nvPr/>
        </p:nvGrpSpPr>
        <p:grpSpPr>
          <a:xfrm>
            <a:off x="301496" y="537796"/>
            <a:ext cx="2315476" cy="2046980"/>
            <a:chOff x="1389051" y="1022374"/>
            <a:chExt cx="3714044" cy="3159304"/>
          </a:xfrm>
        </p:grpSpPr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D5C70FCF-239D-55D7-52BA-1A01EC38DE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5688" r="24760"/>
            <a:stretch/>
          </p:blipFill>
          <p:spPr>
            <a:xfrm>
              <a:off x="1614726" y="1206705"/>
              <a:ext cx="3269162" cy="2974973"/>
            </a:xfrm>
            <a:prstGeom prst="rect">
              <a:avLst/>
            </a:prstGeom>
          </p:spPr>
        </p:pic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3C6B78A7-B6AF-C1D9-56BE-824DD8B589AE}"/>
                </a:ext>
              </a:extLst>
            </p:cNvPr>
            <p:cNvSpPr txBox="1"/>
            <p:nvPr/>
          </p:nvSpPr>
          <p:spPr>
            <a:xfrm>
              <a:off x="1389051" y="3544286"/>
              <a:ext cx="707307" cy="3325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110004020202020204"/>
                  <a:ea typeface="+mn-ea"/>
                  <a:cs typeface="+mn-cs"/>
                </a:rPr>
                <a:t>FB</a:t>
              </a:r>
              <a:endParaRPr lang="fr-FR" sz="800" b="1" dirty="0"/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91F125EF-8C6B-3D0B-0592-962077B5394D}"/>
                </a:ext>
              </a:extLst>
            </p:cNvPr>
            <p:cNvSpPr txBox="1"/>
            <p:nvPr/>
          </p:nvSpPr>
          <p:spPr>
            <a:xfrm>
              <a:off x="2895654" y="1022374"/>
              <a:ext cx="707305" cy="3325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800" b="1" dirty="0" err="1">
                  <a:solidFill>
                    <a:prstClr val="black"/>
                  </a:solidFill>
                  <a:latin typeface="Aptos" panose="02110004020202020204"/>
                </a:rPr>
                <a:t>KTu</a:t>
              </a:r>
              <a:endParaRPr lang="fr-FR" sz="800" b="1" dirty="0"/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D6AB87F4-FDCF-66C7-7B64-C014041D6F01}"/>
                </a:ext>
              </a:extLst>
            </p:cNvPr>
            <p:cNvSpPr txBox="1"/>
            <p:nvPr/>
          </p:nvSpPr>
          <p:spPr>
            <a:xfrm>
              <a:off x="4395788" y="3494017"/>
              <a:ext cx="707307" cy="3325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800" b="1" dirty="0" err="1">
                  <a:solidFill>
                    <a:prstClr val="black"/>
                  </a:solidFill>
                  <a:latin typeface="Aptos" panose="02110004020202020204"/>
                </a:rPr>
                <a:t>KTd</a:t>
              </a:r>
              <a:endParaRPr lang="fr-FR" sz="800" b="1" dirty="0"/>
            </a:p>
          </p:txBody>
        </p:sp>
      </p:grpSp>
      <p:pic>
        <p:nvPicPr>
          <p:cNvPr id="23" name="Image 22">
            <a:extLst>
              <a:ext uri="{FF2B5EF4-FFF2-40B4-BE49-F238E27FC236}">
                <a16:creationId xmlns:a16="http://schemas.microsoft.com/office/drawing/2014/main" id="{96FB740E-6314-F69A-2ACD-9F8A90D3E5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93756" y="592579"/>
            <a:ext cx="3554254" cy="2506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01370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47C48CF-877F-F172-1BFF-69D2FD67BA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104" y="628849"/>
            <a:ext cx="5762244" cy="14523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04307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hèm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bddddbb1-db54-40d5-b230-0609bcef2068}" enabled="0" method="" siteId="{bddddbb1-db54-40d5-b230-0609bcef2068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56</TotalTime>
  <Words>60</Words>
  <Application>Microsoft Office PowerPoint</Application>
  <PresentationFormat>A4 Paper (210x297 mm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Helvetica</vt:lpstr>
      <vt:lpstr>Thèm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ure VERT</dc:creator>
  <cp:lastModifiedBy>Laure VERT</cp:lastModifiedBy>
  <cp:revision>4</cp:revision>
  <dcterms:created xsi:type="dcterms:W3CDTF">2025-11-07T09:35:57Z</dcterms:created>
  <dcterms:modified xsi:type="dcterms:W3CDTF">2026-01-23T09:00:40Z</dcterms:modified>
</cp:coreProperties>
</file>